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>
        <p:scale>
          <a:sx n="130" d="100"/>
          <a:sy n="130" d="100"/>
        </p:scale>
        <p:origin x="1368" y="-93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561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911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857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9056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894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788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5323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1479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771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915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8621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124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4E3630F-A96B-1564-D1A0-64027CE9F8C2}"/>
              </a:ext>
            </a:extLst>
          </p:cNvPr>
          <p:cNvSpPr txBox="1"/>
          <p:nvPr/>
        </p:nvSpPr>
        <p:spPr>
          <a:xfrm>
            <a:off x="0" y="-121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53FB710A-6341-7148-6CD6-3B2CEA4B41D7}"/>
              </a:ext>
            </a:extLst>
          </p:cNvPr>
          <p:cNvGrpSpPr/>
          <p:nvPr/>
        </p:nvGrpSpPr>
        <p:grpSpPr>
          <a:xfrm>
            <a:off x="1392493" y="659580"/>
            <a:ext cx="4397477" cy="5863303"/>
            <a:chOff x="1392493" y="659580"/>
            <a:chExt cx="4397477" cy="5863303"/>
          </a:xfrm>
        </p:grpSpPr>
        <p:pic>
          <p:nvPicPr>
            <p:cNvPr id="5" name="図 4" descr="木の枝で植えている植物&#10;&#10;中程度の精度で自動的に生成された説明">
              <a:extLst>
                <a:ext uri="{FF2B5EF4-FFF2-40B4-BE49-F238E27FC236}">
                  <a16:creationId xmlns:a16="http://schemas.microsoft.com/office/drawing/2014/main" id="{83465A5D-D91F-9BF5-59C8-1FA45EDA996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659580" y="1392493"/>
              <a:ext cx="5863303" cy="4397477"/>
            </a:xfrm>
            <a:prstGeom prst="rect">
              <a:avLst/>
            </a:prstGeom>
          </p:spPr>
        </p:pic>
        <p:sp>
          <p:nvSpPr>
            <p:cNvPr id="8" name="矢印: 下 7">
              <a:extLst>
                <a:ext uri="{FF2B5EF4-FFF2-40B4-BE49-F238E27FC236}">
                  <a16:creationId xmlns:a16="http://schemas.microsoft.com/office/drawing/2014/main" id="{296FF889-E826-EBDF-1C9B-3957CB57072F}"/>
                </a:ext>
              </a:extLst>
            </p:cNvPr>
            <p:cNvSpPr/>
            <p:nvPr/>
          </p:nvSpPr>
          <p:spPr>
            <a:xfrm rot="3484643">
              <a:off x="3061824" y="1462409"/>
              <a:ext cx="258097" cy="435077"/>
            </a:xfrm>
            <a:prstGeom prst="downArrow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9EA27B87-E696-8135-3701-F0B0001E1350}"/>
                </a:ext>
              </a:extLst>
            </p:cNvPr>
            <p:cNvSpPr txBox="1"/>
            <p:nvPr/>
          </p:nvSpPr>
          <p:spPr>
            <a:xfrm>
              <a:off x="3355258" y="1310615"/>
              <a:ext cx="877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ymph</a:t>
              </a:r>
              <a:endParaRPr kumimoji="1" lang="ja-JP" alt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矢印: 下 10">
              <a:extLst>
                <a:ext uri="{FF2B5EF4-FFF2-40B4-BE49-F238E27FC236}">
                  <a16:creationId xmlns:a16="http://schemas.microsoft.com/office/drawing/2014/main" id="{1EDB4767-6B56-F85A-A415-289E02C12929}"/>
                </a:ext>
              </a:extLst>
            </p:cNvPr>
            <p:cNvSpPr/>
            <p:nvPr/>
          </p:nvSpPr>
          <p:spPr>
            <a:xfrm rot="12136581">
              <a:off x="1996764" y="3409069"/>
              <a:ext cx="258097" cy="435077"/>
            </a:xfrm>
            <a:prstGeom prst="downArrow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396FB822-BD0D-DA07-D0DE-59F9113608A6}"/>
                </a:ext>
              </a:extLst>
            </p:cNvPr>
            <p:cNvSpPr txBox="1"/>
            <p:nvPr/>
          </p:nvSpPr>
          <p:spPr>
            <a:xfrm>
              <a:off x="1630066" y="3798958"/>
              <a:ext cx="6976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dult</a:t>
              </a:r>
              <a:endParaRPr kumimoji="1" lang="ja-JP" alt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8AF07A5-81DD-F84B-117E-DF1E7849C9BB}"/>
              </a:ext>
            </a:extLst>
          </p:cNvPr>
          <p:cNvSpPr txBox="1"/>
          <p:nvPr/>
        </p:nvSpPr>
        <p:spPr>
          <a:xfrm>
            <a:off x="246201" y="6774525"/>
            <a:ext cx="654785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young shoots of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p..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ults and nymphs of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ic on young shoots  in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es of the experimental greenhouse of Oshima Branch Kagoshima Prefectural Institute for Agricultural Development. A large number of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parasitic with secreting waxy substances. Plants have many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roducts (including eggs in some cases) attached to them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88748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23</TotalTime>
  <Words>80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藤川貴史</cp:lastModifiedBy>
  <cp:revision>8</cp:revision>
  <dcterms:created xsi:type="dcterms:W3CDTF">2024-04-04T00:00:11Z</dcterms:created>
  <dcterms:modified xsi:type="dcterms:W3CDTF">2024-04-04T08:43:27Z</dcterms:modified>
</cp:coreProperties>
</file>